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47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4DC3DE-EEC7-4159-B377-AA034BE574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B8B47DC-1F43-41B0-BE33-90742713AA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9346682-9C19-492D-889C-E922E17AE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9EECA7-9363-43BE-A64D-85E470701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AD0E8D7-3D48-4DC8-9AB0-975E18948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11610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6AAD90-99F5-43DC-B72E-BEB75D5922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B159A33-E22B-4974-BD66-45B0203502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BC276D2-B074-49B4-BD55-9ED7E101B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64E61F-54DD-451C-AFCF-F4384AE7B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151221B-E3EB-49BD-A229-22319B2A3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42849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AC18792-CDE7-42BA-8302-A05260EF69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AC2BC37-D1DC-4E6F-B044-45D0747E43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780A22-143B-4F42-9D3D-567B29D94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EDBE398-C63B-496D-8A91-B5348791B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55C1DA-8BF2-40CE-803F-6C4802783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08738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833AC3-B3B6-4443-964B-B9471D447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57E1538-9F67-4E78-987D-4CD7B63D22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11DD4DF-1C07-449D-BEC8-57F4F5415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C7B9003-AFA6-4585-9616-020EF8FE9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367B1B-A7CE-4076-AB94-B06A89D81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42017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D4763F-152F-411C-B0D6-EF08B29C0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7AF01AC-DC65-4AED-BA68-0DC91E0D5B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61F354-00D2-4B5E-BFA1-5FC05823B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F28BEB-6898-4E3D-96B2-691DBAF12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909DAD6-A698-4CD0-BA85-AD1498E44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71088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06036A-D698-46C1-9B32-6BE2FD3CA1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6312278-F251-4673-8D67-88191FD227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40AACC7-0D00-4D85-809F-C695B5154F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0A5ABE6-1589-4AA7-8354-23B6EED57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FFA2AA8-E8B2-498E-90B5-7B8A9C71E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310B347-AF28-4F2B-BF4D-206D91CA8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6149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D214E1B-9E4C-476A-BD92-6055D0CEE9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00BFDE9-B72D-4A29-AC18-22EF9B7A9B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6A38E18-55A4-4AF1-A773-7872DF1690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A3EF6B8-EAE3-4404-BFD9-5BFD28B24C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324B69C-692D-42B1-A567-6FA2BD2BEB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F9EB2A4-249B-462B-9CCC-20EF5668D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2B85B42-3756-47F0-97D6-6791E3E87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FEB15F0-C98A-4D9F-8CC3-665AC9F7E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35718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AEEF64B-AD8E-4520-949C-88A77DC17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33ADD98-C3B9-4E5A-A0B8-910476E4D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8A39E37-1E08-4C17-BD25-5865BC66B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B7D1CB9D-CB5B-40EB-B20A-A39495988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59337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0FDEABC-3EA5-4F88-8829-314CD0562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80F9EBD4-AA97-430A-8674-995BDC379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4924E7C-3E73-4032-8490-5EA660272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0083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5DC848-9FFF-4E02-A228-CDB1737F7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18E394F-AB22-4D00-9E46-EB1F0CDDC8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C8521DA-81C0-4769-8607-83A801243B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8F2C1CB-1F5E-4EC5-886A-379727A89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40B07EE-B026-4BB7-A28A-EBC8C1901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9070B6C-871D-4AE5-8C58-A63BCE78E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3627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F496872-6173-4B8D-A9C5-BE6D41AB0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DEB4F6E-8BA3-4653-BA95-FF1A7F7D15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3C1F2C0-8C20-4A7B-A5AD-8A671A4072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04C43FC-AEB6-4EE2-972A-C50DA65DD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0CA43DE-9B28-4893-B4B0-7EC85735B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C25BF42-AB36-486F-BB53-14D2AFC11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80356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2F10504-56B0-46E4-A9A3-B67AEFBEB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2A9B262-F0B8-4DAE-9B41-7D1CDC45F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89854A2-7A4C-4342-A42A-987AE785C6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A3EAA-58EF-4CA8-B74E-B31E106F08D3}" type="datetimeFigureOut">
              <a:rPr lang="es-MX" smtClean="0"/>
              <a:t>19/09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10C081-23E6-4236-B6B3-AAB9120035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63CFDC-8A00-4CA0-A2AB-02AF93EA62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885B-9A49-48B6-A9B6-32EB06E0961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11993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image" Target="../media/image6.jpg"/><Relationship Id="rId3" Type="http://schemas.microsoft.com/office/2007/relationships/media" Target="../media/media2.wav"/><Relationship Id="rId7" Type="http://schemas.openxmlformats.org/officeDocument/2006/relationships/slideLayout" Target="../slideLayouts/slideLayout1.xml"/><Relationship Id="rId12" Type="http://schemas.openxmlformats.org/officeDocument/2006/relationships/image" Target="../media/image5.jpg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audio" Target="../media/media3.wav"/><Relationship Id="rId11" Type="http://schemas.openxmlformats.org/officeDocument/2006/relationships/image" Target="../media/image4.jpg"/><Relationship Id="rId5" Type="http://schemas.microsoft.com/office/2007/relationships/media" Target="../media/media3.wav"/><Relationship Id="rId10" Type="http://schemas.openxmlformats.org/officeDocument/2006/relationships/image" Target="../media/image3.jpeg"/><Relationship Id="rId4" Type="http://schemas.openxmlformats.org/officeDocument/2006/relationships/audio" Target="../media/media2.wav"/><Relationship Id="rId9" Type="http://schemas.openxmlformats.org/officeDocument/2006/relationships/image" Target="../media/image2.jpg"/><Relationship Id="rId1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uadroTexto 12"/>
          <p:cNvSpPr txBox="1"/>
          <p:nvPr/>
        </p:nvSpPr>
        <p:spPr>
          <a:xfrm>
            <a:off x="5774972" y="2393959"/>
            <a:ext cx="34244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etophaga</a:t>
            </a:r>
            <a:r>
              <a:rPr lang="es-ES_tradnl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etechia</a:t>
            </a:r>
            <a:r>
              <a:rPr lang="es-ES_tradnl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bryanti</a:t>
            </a:r>
            <a:r>
              <a:rPr lang="es-ES_tradnl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5428191" y="6294116"/>
            <a:ext cx="41421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Intergrad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uadroTexto 16"/>
          <p:cNvSpPr txBox="1"/>
          <p:nvPr/>
        </p:nvSpPr>
        <p:spPr>
          <a:xfrm>
            <a:off x="5469001" y="4334975"/>
            <a:ext cx="36628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Setophaga petechia rufivertex</a:t>
            </a:r>
            <a:endParaRPr lang="es-ES_tradn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olden Warbler at  Golf club fragment.wav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831624" y="5180872"/>
            <a:ext cx="812800" cy="812800"/>
          </a:xfrm>
          <a:prstGeom prst="rect">
            <a:avLst/>
          </a:prstGeom>
        </p:spPr>
      </p:pic>
      <p:pic>
        <p:nvPicPr>
          <p:cNvPr id="7" name="Mangrove Warbler Isla de pasion fragment.wav">
            <a:hlinkClick r:id="" action="ppaction://media"/>
          </p:cNvPr>
          <p:cNvPicPr>
            <a:picLocks noChangeAspect="1"/>
          </p:cNvPicPr>
          <p:nvPr>
            <a:audi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777678" y="3138965"/>
            <a:ext cx="812800" cy="812800"/>
          </a:xfrm>
          <a:prstGeom prst="rect">
            <a:avLst/>
          </a:prstGeom>
        </p:spPr>
      </p:pic>
      <p:pic>
        <p:nvPicPr>
          <p:cNvPr id="15" name="Mangrove Warbler RLBR fragment.wav">
            <a:hlinkClick r:id="" action="ppaction://media"/>
          </p:cNvPr>
          <p:cNvPicPr>
            <a:picLocks noChangeAspect="1"/>
          </p:cNvPicPr>
          <p:nvPr>
            <a:audi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806655" y="1228308"/>
            <a:ext cx="812800" cy="812800"/>
          </a:xfrm>
          <a:prstGeom prst="rect">
            <a:avLst/>
          </a:prstGeom>
        </p:spPr>
      </p:pic>
      <p:sp>
        <p:nvSpPr>
          <p:cNvPr id="18" name="CuadroTexto 17"/>
          <p:cNvSpPr txBox="1"/>
          <p:nvPr/>
        </p:nvSpPr>
        <p:spPr>
          <a:xfrm>
            <a:off x="2992627" y="2393445"/>
            <a:ext cx="14333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Ría Lagartos</a:t>
            </a:r>
            <a:endParaRPr lang="es-ES_tradn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2730038" y="6323107"/>
            <a:ext cx="34908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Cieg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Lagoon – Cozumel Island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2934672" y="4343608"/>
            <a:ext cx="27613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olf Club - Cozumel Island </a:t>
            </a:r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7A0970DB-5C17-4CE4-AC91-38F8BE8A3DD0}"/>
              </a:ext>
            </a:extLst>
          </p:cNvPr>
          <p:cNvSpPr/>
          <p:nvPr/>
        </p:nvSpPr>
        <p:spPr>
          <a:xfrm>
            <a:off x="0" y="157293"/>
            <a:ext cx="12191999" cy="5232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ong spectrograms of </a:t>
            </a:r>
            <a:r>
              <a:rPr lang="en-US" sz="2800" b="1" i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etophaga petechia </a:t>
            </a:r>
            <a:endParaRPr lang="en-US" sz="2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Imagen 20">
            <a:extLst>
              <a:ext uri="{FF2B5EF4-FFF2-40B4-BE49-F238E27FC236}">
                <a16:creationId xmlns:a16="http://schemas.microsoft.com/office/drawing/2014/main" id="{FCFDE03B-A5B8-4A8A-AE28-2AA4A901CB4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5" t="13961" r="13822" b="33021"/>
          <a:stretch/>
        </p:blipFill>
        <p:spPr>
          <a:xfrm>
            <a:off x="3059083" y="999658"/>
            <a:ext cx="5847722" cy="1443974"/>
          </a:xfrm>
          <a:prstGeom prst="rect">
            <a:avLst/>
          </a:prstGeom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D796AAF6-404B-4966-90EE-FC609CE183AF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332" t="19054" r="18523" b="22033"/>
          <a:stretch/>
        </p:blipFill>
        <p:spPr>
          <a:xfrm>
            <a:off x="8993732" y="999659"/>
            <a:ext cx="1443973" cy="1443974"/>
          </a:xfrm>
          <a:prstGeom prst="rect">
            <a:avLst/>
          </a:prstGeom>
        </p:spPr>
      </p:pic>
      <p:pic>
        <p:nvPicPr>
          <p:cNvPr id="24" name="Imagen 23">
            <a:extLst>
              <a:ext uri="{FF2B5EF4-FFF2-40B4-BE49-F238E27FC236}">
                <a16:creationId xmlns:a16="http://schemas.microsoft.com/office/drawing/2014/main" id="{DEB9805E-2A96-40A6-A14C-10917CB3359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54" t="14987" r="10567" b="32980"/>
          <a:stretch/>
        </p:blipFill>
        <p:spPr>
          <a:xfrm>
            <a:off x="3059083" y="2895276"/>
            <a:ext cx="5852161" cy="1448332"/>
          </a:xfrm>
          <a:prstGeom prst="rect">
            <a:avLst/>
          </a:prstGeom>
        </p:spPr>
      </p:pic>
      <p:pic>
        <p:nvPicPr>
          <p:cNvPr id="25" name="Imagen 24">
            <a:extLst>
              <a:ext uri="{FF2B5EF4-FFF2-40B4-BE49-F238E27FC236}">
                <a16:creationId xmlns:a16="http://schemas.microsoft.com/office/drawing/2014/main" id="{A6E2501E-FDA4-4ECA-AEC4-14389C55F74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035655" y="2920436"/>
            <a:ext cx="1319719" cy="1392062"/>
          </a:xfrm>
          <a:prstGeom prst="rect">
            <a:avLst/>
          </a:prstGeom>
        </p:spPr>
      </p:pic>
      <p:pic>
        <p:nvPicPr>
          <p:cNvPr id="26" name="Imagen 25">
            <a:extLst>
              <a:ext uri="{FF2B5EF4-FFF2-40B4-BE49-F238E27FC236}">
                <a16:creationId xmlns:a16="http://schemas.microsoft.com/office/drawing/2014/main" id="{8DE824C9-D519-4D29-9A4C-29BD22217ED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1" t="13994" r="15608" b="33655"/>
          <a:stretch/>
        </p:blipFill>
        <p:spPr>
          <a:xfrm>
            <a:off x="3054298" y="4873915"/>
            <a:ext cx="5884981" cy="1426715"/>
          </a:xfrm>
          <a:prstGeom prst="rect">
            <a:avLst/>
          </a:prstGeom>
        </p:spPr>
      </p:pic>
      <p:pic>
        <p:nvPicPr>
          <p:cNvPr id="27" name="Imagen 26">
            <a:extLst>
              <a:ext uri="{FF2B5EF4-FFF2-40B4-BE49-F238E27FC236}">
                <a16:creationId xmlns:a16="http://schemas.microsoft.com/office/drawing/2014/main" id="{4CA98935-CDBC-4FC5-A890-7088708D44B8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2909"/>
          <a:stretch/>
        </p:blipFill>
        <p:spPr>
          <a:xfrm>
            <a:off x="9044561" y="4870633"/>
            <a:ext cx="1391583" cy="1433278"/>
          </a:xfrm>
          <a:prstGeom prst="rect">
            <a:avLst/>
          </a:prstGeom>
        </p:spPr>
      </p:pic>
      <p:sp>
        <p:nvSpPr>
          <p:cNvPr id="2" name="Rectángulo: esquinas redondeadas 1">
            <a:extLst>
              <a:ext uri="{FF2B5EF4-FFF2-40B4-BE49-F238E27FC236}">
                <a16:creationId xmlns:a16="http://schemas.microsoft.com/office/drawing/2014/main" id="{81F1675C-6EF4-4239-80FE-1D54598E40FE}"/>
              </a:ext>
            </a:extLst>
          </p:cNvPr>
          <p:cNvSpPr/>
          <p:nvPr/>
        </p:nvSpPr>
        <p:spPr>
          <a:xfrm>
            <a:off x="1249961" y="855677"/>
            <a:ext cx="9778214" cy="1892885"/>
          </a:xfrm>
          <a:prstGeom prst="roundRect">
            <a:avLst/>
          </a:prstGeom>
          <a:noFill/>
          <a:ln w="381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2" name="Rectángulo: esquinas redondeadas 21">
            <a:extLst>
              <a:ext uri="{FF2B5EF4-FFF2-40B4-BE49-F238E27FC236}">
                <a16:creationId xmlns:a16="http://schemas.microsoft.com/office/drawing/2014/main" id="{4BCB33B4-2F9D-441A-832B-8FEAC288F508}"/>
              </a:ext>
            </a:extLst>
          </p:cNvPr>
          <p:cNvSpPr/>
          <p:nvPr/>
        </p:nvSpPr>
        <p:spPr>
          <a:xfrm>
            <a:off x="1251359" y="2836879"/>
            <a:ext cx="9778214" cy="1892885"/>
          </a:xfrm>
          <a:prstGeom prst="round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8" name="Rectángulo: esquinas redondeadas 27">
            <a:extLst>
              <a:ext uri="{FF2B5EF4-FFF2-40B4-BE49-F238E27FC236}">
                <a16:creationId xmlns:a16="http://schemas.microsoft.com/office/drawing/2014/main" id="{CEFBE43D-EF2D-42B6-8FF1-8A30EE291377}"/>
              </a:ext>
            </a:extLst>
          </p:cNvPr>
          <p:cNvSpPr/>
          <p:nvPr/>
        </p:nvSpPr>
        <p:spPr>
          <a:xfrm>
            <a:off x="1252757" y="4826470"/>
            <a:ext cx="9778214" cy="1892885"/>
          </a:xfrm>
          <a:prstGeom prst="roundRect">
            <a:avLst/>
          </a:prstGeom>
          <a:noFill/>
          <a:ln w="3810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267629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1400">
        <p14:doors dir="vert"/>
      </p:transition>
    </mc:Choice>
    <mc:Fallback xmlns="">
      <p:transition spd="slow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25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6553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audio>
              <p:cMediaNode vol="80000">
                <p:cTn id="13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6027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5"/>
                  </p:tgtEl>
                </p:cond>
              </p:nextCondLst>
            </p:seq>
            <p:audio>
              <p:cMediaNode vol="100000">
                <p:cTn id="19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5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4</Words>
  <Application>Microsoft Office PowerPoint</Application>
  <PresentationFormat>Panorámica</PresentationFormat>
  <Paragraphs>7</Paragraphs>
  <Slides>1</Slides>
  <Notes>0</Notes>
  <HiddenSlides>0</HiddenSlides>
  <MMClips>3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lima Henaut</dc:creator>
  <cp:lastModifiedBy>Salima Henaut</cp:lastModifiedBy>
  <cp:revision>4</cp:revision>
  <dcterms:created xsi:type="dcterms:W3CDTF">2021-10-22T15:55:43Z</dcterms:created>
  <dcterms:modified xsi:type="dcterms:W3CDTF">2022-09-19T17:07:58Z</dcterms:modified>
</cp:coreProperties>
</file>